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88"/>
    <p:restoredTop sz="94655"/>
  </p:normalViewPr>
  <p:slideViewPr>
    <p:cSldViewPr snapToGrid="0" snapToObjects="1">
      <p:cViewPr varScale="1">
        <p:scale>
          <a:sx n="100" d="100"/>
          <a:sy n="100" d="100"/>
        </p:scale>
        <p:origin x="512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D4C0C8-10EE-3040-9647-4AF907ED9D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E063C7-B0F2-5B4A-9211-6F13D1B526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FE3F9A-150E-1841-BA5E-EA9529581C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4BDA0C-3E88-3246-BA83-2389475D9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C190C7-0C88-9740-A953-6B2A2B46CD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439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F2544B-FEAF-2E46-91A6-0FD04724EC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A97ED8-BF34-FE4D-A5F5-DBD7A38F1F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1608F3-FE09-9347-BE11-6602AEF32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AE02DE-E98C-164F-BC53-C55B84309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43300-F068-8449-B941-74DF5C0CA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303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91F52AC-E9F0-E143-B582-7051132F7E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0B3CC4-ABA7-A543-B8DB-A116F18024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6BC685-ED90-2E4A-A95A-579496314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AC1D62-3B62-DC49-8D58-B0A787E16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CBEBB1-A312-2C41-A914-EA93D34BF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7546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230FB1-7117-9C4A-A342-BC4317D37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E593B3-E577-F841-AC3D-A0455F310D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CE7E46-D128-E642-AF4A-FCA830D95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3562B9-C18C-5846-BC48-31C2928C6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A8F514-1EB1-4E40-9B8C-F24037A9C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449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17E7F9-BC83-3F4A-8423-0AD95162C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F6A648-63B6-5346-AFE2-F32B5604B8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D6CD26-B13F-6F43-9AB9-081FE299F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32832F-0EA8-F34F-BCDF-A86C456FE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D26636-55DA-B541-9047-21FF37AE1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3040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4A70B-7B09-8A4D-B74E-C527F3C2EC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1E5F96-11F5-7746-83C3-CA37B82B15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4DD312-94B4-D04C-91F6-8A4499D076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FC19B7-0D4C-B346-AFA5-F12AD9476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C9A34A-7632-2240-AB2F-D1EC3B119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F6E7AB-CC16-A842-8368-9FA62AA5D4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257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E0A974-5EE2-364F-A6D9-545EF5EF25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5114B4-9DD0-EF44-BF91-D2A638350A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6EAF5E-BA37-CA49-9198-7430C656AD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690C662-76E4-5940-89B7-2533EE920E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EC45C2-F067-2C4D-93B9-B7F6E13D8E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07A0FA-4CD9-C749-B8CE-AC0FE6A3A4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8A4A5A-3B8C-324D-811A-60B4F62AD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F643B8-9804-8D44-B77D-9726ED8CD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713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30CB8-9852-AD40-89C4-C732F2984B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8163AC-CD48-DB49-A7F4-00302BD9D2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8E3919D-B0C3-4B45-878E-9651AF4E53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12AEFB3-20D1-FE44-A98B-527E91A12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8263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D4CEDD5-7AA8-954B-82B7-A3BD64D86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16FF31-F5DA-BF4A-BC8D-882AB77000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8BD0ED-3E8F-D646-91EB-53FE41FB1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503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CDF650-6DC5-A148-809E-205B45DE7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3C5BA5-DC43-CE43-BB8E-0A53FDEEC0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568E7F-9AA5-2947-B878-9A704D18AC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A3032E-C47C-7F4B-9917-1F3CDB6BB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A82864-4E98-5B44-B9E0-6FE14A708E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E5FD35-3A9E-FB40-A385-1D49CE6BD2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281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DA48D-D0A4-A644-82AC-80A5276408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B27D48-2A73-E849-840A-2289DCDDD9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76DF79-81CB-AB46-B3AD-B6334262373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B0FFF3-1339-4746-B8C6-5196B7FEA9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595023-2B14-434D-9AD4-B64E2CD73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5F830F-606B-6046-ACF0-B2474FFC0C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766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F1E0EC-40E3-8340-8894-BD1A1A888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C42900-3A1B-454E-A1B7-35F27B277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6BF06D-B6B1-5D42-9FBC-5A37F8ECF1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AA0BE-7752-B24F-A792-028860F69D97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F23D5B-0729-774F-AEF1-AF4E2D8DA46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2790CD-0756-564A-B395-4F55AE6497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C06EA0-93FC-7542-8A7B-DCB0E3973E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309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E23F757-5E29-AC4D-8DDB-15B6E4C76227}"/>
              </a:ext>
            </a:extLst>
          </p:cNvPr>
          <p:cNvSpPr txBox="1"/>
          <p:nvPr/>
        </p:nvSpPr>
        <p:spPr>
          <a:xfrm>
            <a:off x="466886" y="436956"/>
            <a:ext cx="1847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2B19138-A062-F145-8B70-C2E841E74E83}"/>
              </a:ext>
            </a:extLst>
          </p:cNvPr>
          <p:cNvSpPr txBox="1"/>
          <p:nvPr/>
        </p:nvSpPr>
        <p:spPr>
          <a:xfrm rot="16200000">
            <a:off x="-69018" y="1357080"/>
            <a:ext cx="1557301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 cell expression (%)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5EB57F3B-7C49-A14B-9626-91AB939B6478}"/>
              </a:ext>
            </a:extLst>
          </p:cNvPr>
          <p:cNvGrpSpPr/>
          <p:nvPr/>
        </p:nvGrpSpPr>
        <p:grpSpPr>
          <a:xfrm>
            <a:off x="891676" y="590844"/>
            <a:ext cx="3766505" cy="1682420"/>
            <a:chOff x="2760416" y="474454"/>
            <a:chExt cx="3766505" cy="1682420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90E864A8-4F6C-E840-92EE-CB6D73F6AF8D}"/>
                </a:ext>
              </a:extLst>
            </p:cNvPr>
            <p:cNvGrpSpPr/>
            <p:nvPr/>
          </p:nvGrpSpPr>
          <p:grpSpPr>
            <a:xfrm>
              <a:off x="2760416" y="592844"/>
              <a:ext cx="3739327" cy="1564030"/>
              <a:chOff x="4489735" y="3602018"/>
              <a:chExt cx="3739327" cy="1564030"/>
            </a:xfrm>
          </p:grpSpPr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A7650593-8D02-BA4D-BE52-7588C4C8BC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489735" y="3643928"/>
                <a:ext cx="1864995" cy="1355090"/>
              </a:xfrm>
              <a:prstGeom prst="rect">
                <a:avLst/>
              </a:prstGeom>
            </p:spPr>
          </p:pic>
          <p:pic>
            <p:nvPicPr>
              <p:cNvPr id="53" name="Picture 52">
                <a:extLst>
                  <a:ext uri="{FF2B5EF4-FFF2-40B4-BE49-F238E27FC236}">
                    <a16:creationId xmlns:a16="http://schemas.microsoft.com/office/drawing/2014/main" id="{DB31CA46-71AF-074C-BE5A-34F8361A16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504922" y="3602018"/>
                <a:ext cx="1711325" cy="1438910"/>
              </a:xfrm>
              <a:prstGeom prst="rect">
                <a:avLst/>
              </a:prstGeom>
            </p:spPr>
          </p:pic>
          <p:grpSp>
            <p:nvGrpSpPr>
              <p:cNvPr id="54" name="Group 53">
                <a:extLst>
                  <a:ext uri="{FF2B5EF4-FFF2-40B4-BE49-F238E27FC236}">
                    <a16:creationId xmlns:a16="http://schemas.microsoft.com/office/drawing/2014/main" id="{FE435608-60D4-7E4F-9C76-E5E65C557BDF}"/>
                  </a:ext>
                </a:extLst>
              </p:cNvPr>
              <p:cNvGrpSpPr/>
              <p:nvPr/>
            </p:nvGrpSpPr>
            <p:grpSpPr>
              <a:xfrm>
                <a:off x="4714830" y="4911438"/>
                <a:ext cx="1517293" cy="246221"/>
                <a:chOff x="2601370" y="5094638"/>
                <a:chExt cx="1517293" cy="246221"/>
              </a:xfrm>
            </p:grpSpPr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1974FCE4-B213-614A-9924-4C702C5FB2F4}"/>
                    </a:ext>
                  </a:extLst>
                </p:cNvPr>
                <p:cNvSpPr txBox="1"/>
                <p:nvPr/>
              </p:nvSpPr>
              <p:spPr>
                <a:xfrm>
                  <a:off x="2601370" y="5094638"/>
                  <a:ext cx="36260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B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966A2ECC-A9BF-4C4E-B4F8-22F83A97C9A5}"/>
                    </a:ext>
                  </a:extLst>
                </p:cNvPr>
                <p:cNvSpPr txBox="1"/>
                <p:nvPr/>
              </p:nvSpPr>
              <p:spPr>
                <a:xfrm>
                  <a:off x="3145967" y="5094638"/>
                  <a:ext cx="36260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</a:t>
                  </a: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05BB4848-0764-054B-B338-71F9D95A212C}"/>
                    </a:ext>
                  </a:extLst>
                </p:cNvPr>
                <p:cNvSpPr txBox="1"/>
                <p:nvPr/>
              </p:nvSpPr>
              <p:spPr>
                <a:xfrm>
                  <a:off x="3642251" y="5094638"/>
                  <a:ext cx="47641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BM</a:t>
                  </a:r>
                </a:p>
              </p:txBody>
            </p:sp>
          </p:grpSp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763EF56C-351F-F24A-AD3F-38B5903C27FD}"/>
                  </a:ext>
                </a:extLst>
              </p:cNvPr>
              <p:cNvGrpSpPr/>
              <p:nvPr/>
            </p:nvGrpSpPr>
            <p:grpSpPr>
              <a:xfrm>
                <a:off x="6711769" y="4919827"/>
                <a:ext cx="1517293" cy="246221"/>
                <a:chOff x="2651704" y="5103027"/>
                <a:chExt cx="1517293" cy="246221"/>
              </a:xfrm>
            </p:grpSpPr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240C3ECE-45D3-2C47-8532-8B7B67189A67}"/>
                    </a:ext>
                  </a:extLst>
                </p:cNvPr>
                <p:cNvSpPr txBox="1"/>
                <p:nvPr/>
              </p:nvSpPr>
              <p:spPr>
                <a:xfrm>
                  <a:off x="2651704" y="5103027"/>
                  <a:ext cx="36260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B</a:t>
                  </a: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31813E07-15DF-CC4A-9E26-FF9D52338866}"/>
                    </a:ext>
                  </a:extLst>
                </p:cNvPr>
                <p:cNvSpPr txBox="1"/>
                <p:nvPr/>
              </p:nvSpPr>
              <p:spPr>
                <a:xfrm>
                  <a:off x="3196301" y="5103027"/>
                  <a:ext cx="362600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B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451DE061-DFF1-ED43-A1E4-3FF36E1E1675}"/>
                    </a:ext>
                  </a:extLst>
                </p:cNvPr>
                <p:cNvSpPr txBox="1"/>
                <p:nvPr/>
              </p:nvSpPr>
              <p:spPr>
                <a:xfrm>
                  <a:off x="3692585" y="5103027"/>
                  <a:ext cx="47641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BM</a:t>
                  </a:r>
                </a:p>
              </p:txBody>
            </p:sp>
          </p:grpSp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id="{F427D713-7905-CD40-8C1F-25E4E1BB0BDC}"/>
                  </a:ext>
                </a:extLst>
              </p:cNvPr>
              <p:cNvGrpSpPr/>
              <p:nvPr/>
            </p:nvGrpSpPr>
            <p:grpSpPr>
              <a:xfrm>
                <a:off x="7399372" y="3815214"/>
                <a:ext cx="510576" cy="246221"/>
                <a:chOff x="7385810" y="4045525"/>
                <a:chExt cx="510576" cy="246221"/>
              </a:xfrm>
            </p:grpSpPr>
            <p:cxnSp>
              <p:nvCxnSpPr>
                <p:cNvPr id="60" name="Straight Connector 59">
                  <a:extLst>
                    <a:ext uri="{FF2B5EF4-FFF2-40B4-BE49-F238E27FC236}">
                      <a16:creationId xmlns:a16="http://schemas.microsoft.com/office/drawing/2014/main" id="{D0427059-105D-9542-9E41-D44EC200BD1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85810" y="4275151"/>
                  <a:ext cx="51057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56FF00A1-FD2B-1E41-9E47-78E6CEE7AC22}"/>
                    </a:ext>
                  </a:extLst>
                </p:cNvPr>
                <p:cNvSpPr txBox="1"/>
                <p:nvPr/>
              </p:nvSpPr>
              <p:spPr>
                <a:xfrm>
                  <a:off x="7500731" y="4045525"/>
                  <a:ext cx="31931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</p:grpSp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C123F596-A436-D34D-B631-35C2C76B428B}"/>
                  </a:ext>
                </a:extLst>
              </p:cNvPr>
              <p:cNvGrpSpPr/>
              <p:nvPr/>
            </p:nvGrpSpPr>
            <p:grpSpPr>
              <a:xfrm>
                <a:off x="5407071" y="3751514"/>
                <a:ext cx="510576" cy="246221"/>
                <a:chOff x="7385810" y="3968155"/>
                <a:chExt cx="510576" cy="246221"/>
              </a:xfrm>
            </p:grpSpPr>
            <p:cxnSp>
              <p:nvCxnSpPr>
                <p:cNvPr id="58" name="Straight Connector 57">
                  <a:extLst>
                    <a:ext uri="{FF2B5EF4-FFF2-40B4-BE49-F238E27FC236}">
                      <a16:creationId xmlns:a16="http://schemas.microsoft.com/office/drawing/2014/main" id="{5068A0FD-8CDA-C94F-A8FB-931522360F2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385810" y="4130298"/>
                  <a:ext cx="51057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27862880-5636-CF44-945A-499469E39945}"/>
                    </a:ext>
                  </a:extLst>
                </p:cNvPr>
                <p:cNvSpPr txBox="1"/>
                <p:nvPr/>
              </p:nvSpPr>
              <p:spPr>
                <a:xfrm>
                  <a:off x="7531205" y="3968155"/>
                  <a:ext cx="28405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20AE7036-5C3F-FA4D-9A53-384F9CB03814}"/>
                </a:ext>
              </a:extLst>
            </p:cNvPr>
            <p:cNvSpPr txBox="1"/>
            <p:nvPr/>
          </p:nvSpPr>
          <p:spPr>
            <a:xfrm>
              <a:off x="3051471" y="474454"/>
              <a:ext cx="845694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AG3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A82D233-828A-4947-9E3F-C9DF55B1746E}"/>
                </a:ext>
              </a:extLst>
            </p:cNvPr>
            <p:cNvSpPr txBox="1"/>
            <p:nvPr/>
          </p:nvSpPr>
          <p:spPr>
            <a:xfrm>
              <a:off x="5023108" y="481707"/>
              <a:ext cx="1037051" cy="4001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TLA-4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1637F4A-D429-2A4B-8311-1F7368277EBD}"/>
                </a:ext>
              </a:extLst>
            </p:cNvPr>
            <p:cNvSpPr txBox="1"/>
            <p:nvPr/>
          </p:nvSpPr>
          <p:spPr>
            <a:xfrm>
              <a:off x="6037447" y="680082"/>
              <a:ext cx="48947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8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5D68D94-2937-2E4E-9886-7189127864AE}"/>
                </a:ext>
              </a:extLst>
            </p:cNvPr>
            <p:cNvSpPr txBox="1"/>
            <p:nvPr/>
          </p:nvSpPr>
          <p:spPr>
            <a:xfrm>
              <a:off x="4023697" y="640900"/>
              <a:ext cx="48947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=7</a:t>
              </a:r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36C614F7-33AF-F44E-85D7-F4509E190523}"/>
              </a:ext>
            </a:extLst>
          </p:cNvPr>
          <p:cNvSpPr txBox="1"/>
          <p:nvPr/>
        </p:nvSpPr>
        <p:spPr>
          <a:xfrm>
            <a:off x="322877" y="165944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D7EEA23-EADB-BE4B-8CA8-D6320386FE00}"/>
              </a:ext>
            </a:extLst>
          </p:cNvPr>
          <p:cNvSpPr txBox="1"/>
          <p:nvPr/>
        </p:nvSpPr>
        <p:spPr>
          <a:xfrm>
            <a:off x="500374" y="2695227"/>
            <a:ext cx="4157807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The cell surface phenotype of GBM-infiltrating lymphocytes</a:t>
            </a:r>
            <a:endParaRPr lang="en-GB" sz="1200" dirty="0"/>
          </a:p>
          <a:p>
            <a:r>
              <a:rPr lang="en-GB" sz="1200" dirty="0"/>
              <a:t>Expression of LAG3 and CTLA-4 on CD3+ T cells in GBM patient tumour (GBM), patient blood (PB) and control blood from healthy donors (CB). Each dot represents a single patient sample (with number of patients samples n analysed for each sample shown); the bar indicates the mean± standard deviation. The patient-derived tumour (GBM) and blood (PB) samples were analysed using a paired t test; *P&lt;0.05, **P&lt;0.01; ***P&lt;0.001; ns: not significant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6422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30</Words>
  <Application>Microsoft Macintosh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a Watson</dc:creator>
  <cp:lastModifiedBy>Erica Watson</cp:lastModifiedBy>
  <cp:revision>4</cp:revision>
  <dcterms:created xsi:type="dcterms:W3CDTF">2019-06-12T07:08:20Z</dcterms:created>
  <dcterms:modified xsi:type="dcterms:W3CDTF">2019-07-01T16:04:43Z</dcterms:modified>
</cp:coreProperties>
</file>